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3.xml" ContentType="application/vnd.ms-office.chartstyle+xml"/>
  <Override PartName="/ppt/charts/colors13.xml" ContentType="application/vnd.ms-office.chartcolorstyle+xml"/>
  <Override PartName="/ppt/charts/style14.xml" ContentType="application/vnd.ms-office.chartstyle+xml"/>
  <Override PartName="/ppt/charts/colors14.xml" ContentType="application/vnd.ms-office.chartcolorstyle+xml"/>
  <Override PartName="/ppt/charts/style15.xml" ContentType="application/vnd.ms-office.chartstyle+xml"/>
  <Override PartName="/ppt/charts/colors15.xml" ContentType="application/vnd.ms-office.chartcolorstyle+xml"/>
  <Override PartName="/ppt/charts/style16.xml" ContentType="application/vnd.ms-office.chartstyle+xml"/>
  <Override PartName="/ppt/charts/colors16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72" autoAdjust="0"/>
    <p:restoredTop sz="94660"/>
  </p:normalViewPr>
  <p:slideViewPr>
    <p:cSldViewPr snapToGrid="0">
      <p:cViewPr>
        <p:scale>
          <a:sx n="100" d="100"/>
          <a:sy n="100" d="100"/>
        </p:scale>
        <p:origin x="0" y="2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13.xml"/><Relationship Id="rId3" Type="http://schemas.microsoft.com/office/2011/relationships/chartColorStyle" Target="colors13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14.xml"/><Relationship Id="rId3" Type="http://schemas.microsoft.com/office/2011/relationships/chartColorStyle" Target="colors14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15.xml"/><Relationship Id="rId3" Type="http://schemas.microsoft.com/office/2011/relationships/chartColorStyle" Target="colors15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jahvid.lssa.ucla.edu\White%20Lab\Jon\DREADDS%20publication\Final%20SUMMARY%20LMAN%20and%20X.xlsx" TargetMode="External"/><Relationship Id="rId2" Type="http://schemas.microsoft.com/office/2011/relationships/chartStyle" Target="style16.xml"/><Relationship Id="rId3" Type="http://schemas.microsoft.com/office/2011/relationships/chartColorStyle" Target="colors1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90164315398075"/>
          <c:y val="0.0406946631671041"/>
          <c:w val="0.906678012904637"/>
          <c:h val="0.863055118110236"/>
        </c:manualLayout>
      </c:layout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1F4-4DB8-BEC6-1628FE9089C9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AreaX_Average, HSV only'!$B$50,'AreaX_Average, HSV only'!$D$50:$K$50)</c:f>
                <c:numCache>
                  <c:formatCode>General</c:formatCode>
                  <c:ptCount val="9"/>
                  <c:pt idx="0">
                    <c:v>0.0596765663302126</c:v>
                  </c:pt>
                  <c:pt idx="1">
                    <c:v>0.0556743995928755</c:v>
                  </c:pt>
                  <c:pt idx="2">
                    <c:v>0.0482241434627393</c:v>
                  </c:pt>
                  <c:pt idx="3">
                    <c:v>0.0229482318602479</c:v>
                  </c:pt>
                  <c:pt idx="4">
                    <c:v>0.0296302050675533</c:v>
                  </c:pt>
                  <c:pt idx="5">
                    <c:v>0.0481460821256247</c:v>
                  </c:pt>
                  <c:pt idx="6">
                    <c:v>0.0212500031853538</c:v>
                  </c:pt>
                  <c:pt idx="7">
                    <c:v>0.036237082097063</c:v>
                  </c:pt>
                  <c:pt idx="8">
                    <c:v>0.0254523266199381</c:v>
                  </c:pt>
                </c:numCache>
              </c:numRef>
            </c:plus>
            <c:minus>
              <c:numRef>
                <c:f>('AreaX_Average, HSV only'!$B$50,'AreaX_Average, HSV only'!$D$50:$K$50)</c:f>
                <c:numCache>
                  <c:formatCode>General</c:formatCode>
                  <c:ptCount val="9"/>
                  <c:pt idx="0">
                    <c:v>0.0596765663302126</c:v>
                  </c:pt>
                  <c:pt idx="1">
                    <c:v>0.0556743995928755</c:v>
                  </c:pt>
                  <c:pt idx="2">
                    <c:v>0.0482241434627393</c:v>
                  </c:pt>
                  <c:pt idx="3">
                    <c:v>0.0229482318602479</c:v>
                  </c:pt>
                  <c:pt idx="4">
                    <c:v>0.0296302050675533</c:v>
                  </c:pt>
                  <c:pt idx="5">
                    <c:v>0.0481460821256247</c:v>
                  </c:pt>
                  <c:pt idx="6">
                    <c:v>0.0212500031853538</c:v>
                  </c:pt>
                  <c:pt idx="7">
                    <c:v>0.036237082097063</c:v>
                  </c:pt>
                  <c:pt idx="8">
                    <c:v>0.0254523266199381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('AreaX_Average, HSV only'!$B$48,'AreaX_Average, HSV only'!$D$48:$K$48)</c:f>
              <c:numCache>
                <c:formatCode>General</c:formatCode>
                <c:ptCount val="9"/>
                <c:pt idx="0">
                  <c:v>0.0308927438559215</c:v>
                </c:pt>
                <c:pt idx="1">
                  <c:v>-0.0486071397669912</c:v>
                </c:pt>
                <c:pt idx="2">
                  <c:v>0.0963476406436096</c:v>
                </c:pt>
                <c:pt idx="3">
                  <c:v>-0.0392534342133829</c:v>
                </c:pt>
                <c:pt idx="4">
                  <c:v>-0.0378246343464878</c:v>
                </c:pt>
                <c:pt idx="5">
                  <c:v>0.0219735603472741</c:v>
                </c:pt>
                <c:pt idx="6">
                  <c:v>0.0973738625048147</c:v>
                </c:pt>
                <c:pt idx="7">
                  <c:v>0.0492262426573924</c:v>
                </c:pt>
                <c:pt idx="8">
                  <c:v>0.06676762944404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1F4-4DB8-BEC6-1628FE9089C9}"/>
            </c:ext>
          </c:extLst>
        </c:ser>
        <c:ser>
          <c:idx val="2"/>
          <c:order val="2"/>
          <c:tx>
            <c:v>mCherry</c:v>
          </c:tx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AreaX_Average, HSV only'!$B$55,'AreaX_Average, HSV only'!$D$55:$K$55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plus>
            <c:minus>
              <c:numRef>
                <c:f>('AreaX_Average, HSV only'!$B$55,'AreaX_Average, HSV only'!$D$55:$K$55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('AreaX_Average, HSV only'!$B$53,'AreaX_Average, HSV only'!$D$53:$K$53)</c:f>
              <c:numCache>
                <c:formatCode>General</c:formatCode>
                <c:ptCount val="9"/>
                <c:pt idx="0">
                  <c:v>-0.00717018180753137</c:v>
                </c:pt>
                <c:pt idx="1">
                  <c:v>0.0574937540080207</c:v>
                </c:pt>
                <c:pt idx="2">
                  <c:v>0.00740049973922074</c:v>
                </c:pt>
                <c:pt idx="3">
                  <c:v>0.0169369994483522</c:v>
                </c:pt>
                <c:pt idx="4">
                  <c:v>-0.00765234754301151</c:v>
                </c:pt>
                <c:pt idx="5">
                  <c:v>0.0222960600269891</c:v>
                </c:pt>
                <c:pt idx="6">
                  <c:v>-0.0053356289719826</c:v>
                </c:pt>
                <c:pt idx="7">
                  <c:v>-0.00182609799951625</c:v>
                </c:pt>
                <c:pt idx="8">
                  <c:v>0.03860370805566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1F4-4DB8-BEC6-1628FE9089C9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AreaX_Average, HSV only'!$B$45,'AreaX_Average, HSV only'!$D$45:$K$45)</c:f>
                <c:numCache>
                  <c:formatCode>General</c:formatCode>
                  <c:ptCount val="9"/>
                  <c:pt idx="0">
                    <c:v>0.0183572928435605</c:v>
                  </c:pt>
                  <c:pt idx="1">
                    <c:v>0.0181888920124042</c:v>
                  </c:pt>
                  <c:pt idx="2">
                    <c:v>0.0188660822462473</c:v>
                  </c:pt>
                  <c:pt idx="3">
                    <c:v>0.00678849501795702</c:v>
                  </c:pt>
                  <c:pt idx="4">
                    <c:v>0.0487101794508746</c:v>
                  </c:pt>
                  <c:pt idx="5">
                    <c:v>0.0301472145923379</c:v>
                  </c:pt>
                  <c:pt idx="6">
                    <c:v>0.0108359990487247</c:v>
                  </c:pt>
                  <c:pt idx="7">
                    <c:v>0.0329517728818326</c:v>
                  </c:pt>
                  <c:pt idx="8">
                    <c:v>0.00770125534923274</c:v>
                  </c:pt>
                </c:numCache>
              </c:numRef>
            </c:plus>
            <c:minus>
              <c:numRef>
                <c:f>('AreaX_Average, HSV only'!$B$45,'AreaX_Average, HSV only'!$D$45:$K$45)</c:f>
                <c:numCache>
                  <c:formatCode>General</c:formatCode>
                  <c:ptCount val="9"/>
                  <c:pt idx="0">
                    <c:v>0.0183572928435605</c:v>
                  </c:pt>
                  <c:pt idx="1">
                    <c:v>0.0181888920124042</c:v>
                  </c:pt>
                  <c:pt idx="2">
                    <c:v>0.0188660822462473</c:v>
                  </c:pt>
                  <c:pt idx="3">
                    <c:v>0.00678849501795702</c:v>
                  </c:pt>
                  <c:pt idx="4">
                    <c:v>0.0487101794508746</c:v>
                  </c:pt>
                  <c:pt idx="5">
                    <c:v>0.0301472145923379</c:v>
                  </c:pt>
                  <c:pt idx="6">
                    <c:v>0.0108359990487247</c:v>
                  </c:pt>
                  <c:pt idx="7">
                    <c:v>0.0329517728818326</c:v>
                  </c:pt>
                  <c:pt idx="8">
                    <c:v>0.0077012553492327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('AreaX_Average, HSV only'!$B$43,'AreaX_Average, HSV only'!$D$43:$K$43)</c:f>
              <c:numCache>
                <c:formatCode>General</c:formatCode>
                <c:ptCount val="9"/>
                <c:pt idx="0">
                  <c:v>-0.0111203104709822</c:v>
                </c:pt>
                <c:pt idx="1">
                  <c:v>-0.0762455536119459</c:v>
                </c:pt>
                <c:pt idx="2">
                  <c:v>-0.094240607964417</c:v>
                </c:pt>
                <c:pt idx="3">
                  <c:v>0.00305212678307118</c:v>
                </c:pt>
                <c:pt idx="4">
                  <c:v>-0.0300825449934268</c:v>
                </c:pt>
                <c:pt idx="5">
                  <c:v>-0.00982858794850919</c:v>
                </c:pt>
                <c:pt idx="6">
                  <c:v>-0.106955847679344</c:v>
                </c:pt>
                <c:pt idx="7">
                  <c:v>-0.112798651237279</c:v>
                </c:pt>
                <c:pt idx="8">
                  <c:v>-0.05545503824478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1F4-4DB8-BEC6-1628FE9089C9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1F4-4DB8-BEC6-1628FE9089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11073128"/>
        <c:axId val="-2072207016"/>
      </c:barChart>
      <c:catAx>
        <c:axId val="18110731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72207016"/>
        <c:crosses val="autoZero"/>
        <c:auto val="1"/>
        <c:lblAlgn val="ctr"/>
        <c:lblOffset val="100"/>
        <c:noMultiLvlLbl val="0"/>
      </c:catAx>
      <c:valAx>
        <c:axId val="-2072207016"/>
        <c:scaling>
          <c:orientation val="minMax"/>
          <c:max val="0.18"/>
          <c:min val="-0.1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073128"/>
        <c:crosses val="autoZero"/>
        <c:crossBetween val="between"/>
        <c:majorUnit val="0.09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1F4-4DB8-BEC6-1628FE9089C9}"/>
            </c:ext>
          </c:extLst>
        </c:ser>
        <c:ser>
          <c:idx val="0"/>
          <c:order val="1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AreaX_Average, AAV only'!$B$50,'AreaX_Average, AAV only'!$D$50:$K$50)</c:f>
                <c:numCache>
                  <c:formatCode>General</c:formatCode>
                  <c:ptCount val="9"/>
                  <c:pt idx="0">
                    <c:v>0.063110343945792</c:v>
                  </c:pt>
                  <c:pt idx="1">
                    <c:v>0.144356032056783</c:v>
                  </c:pt>
                  <c:pt idx="2">
                    <c:v>0.0956323288475432</c:v>
                  </c:pt>
                  <c:pt idx="3">
                    <c:v>0.00885026592660254</c:v>
                  </c:pt>
                  <c:pt idx="4">
                    <c:v>0.0540289543520781</c:v>
                  </c:pt>
                  <c:pt idx="5">
                    <c:v>0.0120199255648354</c:v>
                  </c:pt>
                  <c:pt idx="6">
                    <c:v>0.0778189704749262</c:v>
                  </c:pt>
                  <c:pt idx="7">
                    <c:v>0.0531911756320513</c:v>
                  </c:pt>
                  <c:pt idx="8">
                    <c:v>0.0375082996514414</c:v>
                  </c:pt>
                </c:numCache>
              </c:numRef>
            </c:plus>
            <c:minus>
              <c:numRef>
                <c:f>('AreaX_Average, AAV only'!$B$50,'AreaX_Average, AAV only'!$D$50:$K$50)</c:f>
                <c:numCache>
                  <c:formatCode>General</c:formatCode>
                  <c:ptCount val="9"/>
                  <c:pt idx="0">
                    <c:v>0.063110343945792</c:v>
                  </c:pt>
                  <c:pt idx="1">
                    <c:v>0.144356032056783</c:v>
                  </c:pt>
                  <c:pt idx="2">
                    <c:v>0.0956323288475432</c:v>
                  </c:pt>
                  <c:pt idx="3">
                    <c:v>0.00885026592660254</c:v>
                  </c:pt>
                  <c:pt idx="4">
                    <c:v>0.0540289543520781</c:v>
                  </c:pt>
                  <c:pt idx="5">
                    <c:v>0.0120199255648354</c:v>
                  </c:pt>
                  <c:pt idx="6">
                    <c:v>0.0778189704749262</c:v>
                  </c:pt>
                  <c:pt idx="7">
                    <c:v>0.0531911756320513</c:v>
                  </c:pt>
                  <c:pt idx="8">
                    <c:v>0.037508299651441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('AreaX_Average, AAV only'!$B$48,'AreaX_Average, AAV only'!$D$48:$K$48)</c:f>
              <c:numCache>
                <c:formatCode>General</c:formatCode>
                <c:ptCount val="9"/>
                <c:pt idx="0">
                  <c:v>0.0153791643146607</c:v>
                </c:pt>
                <c:pt idx="1">
                  <c:v>-0.0223620011487147</c:v>
                </c:pt>
                <c:pt idx="2">
                  <c:v>0.16279644609806</c:v>
                </c:pt>
                <c:pt idx="3">
                  <c:v>0.00982423578083879</c:v>
                </c:pt>
                <c:pt idx="4">
                  <c:v>0.0381420063495246</c:v>
                </c:pt>
                <c:pt idx="5">
                  <c:v>0.0544596073903386</c:v>
                </c:pt>
                <c:pt idx="6">
                  <c:v>0.0798693829512575</c:v>
                </c:pt>
                <c:pt idx="7">
                  <c:v>0.0313049345100641</c:v>
                </c:pt>
                <c:pt idx="8">
                  <c:v>0.05224832147888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1F4-4DB8-BEC6-1628FE9089C9}"/>
            </c:ext>
          </c:extLst>
        </c:ser>
        <c:ser>
          <c:idx val="2"/>
          <c:order val="2"/>
          <c:tx>
            <c:v>mCherry</c:v>
          </c:tx>
          <c:spPr>
            <a:solidFill>
              <a:schemeClr val="tx1"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AreaX_Average, AAV only'!$B$55,'AreaX_Average, AAV only'!$D$55:$K$55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plus>
            <c:minus>
              <c:numRef>
                <c:f>('AreaX_Average, AAV only'!$B$55,'AreaX_Average, AAV only'!$D$55:$K$55)</c:f>
                <c:numCache>
                  <c:formatCode>General</c:formatCode>
                  <c:ptCount val="9"/>
                  <c:pt idx="0">
                    <c:v>0.0260105525837487</c:v>
                  </c:pt>
                  <c:pt idx="1">
                    <c:v>0.0339186939004047</c:v>
                  </c:pt>
                  <c:pt idx="2">
                    <c:v>0.0351980410379154</c:v>
                  </c:pt>
                  <c:pt idx="3">
                    <c:v>0.0253038835290455</c:v>
                  </c:pt>
                  <c:pt idx="4">
                    <c:v>0.0235115941167981</c:v>
                  </c:pt>
                  <c:pt idx="5">
                    <c:v>0.0182423771333792</c:v>
                  </c:pt>
                  <c:pt idx="6">
                    <c:v>0.032512303547065</c:v>
                  </c:pt>
                  <c:pt idx="7">
                    <c:v>0.0155068750648968</c:v>
                  </c:pt>
                  <c:pt idx="8">
                    <c:v>0.040309592209428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val>
            <c:numRef>
              <c:f>('AreaX_Average, AAV only'!$B$53,'AreaX_Average, AAV only'!$D$53:$K$53)</c:f>
              <c:numCache>
                <c:formatCode>General</c:formatCode>
                <c:ptCount val="9"/>
                <c:pt idx="0">
                  <c:v>-0.00717018180753137</c:v>
                </c:pt>
                <c:pt idx="1">
                  <c:v>0.0574937540080207</c:v>
                </c:pt>
                <c:pt idx="2">
                  <c:v>0.00740049973922074</c:v>
                </c:pt>
                <c:pt idx="3">
                  <c:v>0.0169369994483522</c:v>
                </c:pt>
                <c:pt idx="4">
                  <c:v>-0.00765234754301151</c:v>
                </c:pt>
                <c:pt idx="5">
                  <c:v>0.0222960600269891</c:v>
                </c:pt>
                <c:pt idx="6">
                  <c:v>-0.0053356289719826</c:v>
                </c:pt>
                <c:pt idx="7">
                  <c:v>-0.00182609799951625</c:v>
                </c:pt>
                <c:pt idx="8">
                  <c:v>0.03860370805566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1F4-4DB8-BEC6-1628FE9089C9}"/>
            </c:ext>
          </c:extLst>
        </c:ser>
        <c:ser>
          <c:idx val="1"/>
          <c:order val="3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('AreaX_Average, AAV only'!$B$45,'AreaX_Average, AAV only'!$D$45:$K$45)</c:f>
                <c:numCache>
                  <c:formatCode>General</c:formatCode>
                  <c:ptCount val="9"/>
                  <c:pt idx="0">
                    <c:v>0.058021196097363</c:v>
                  </c:pt>
                  <c:pt idx="1">
                    <c:v>0.0168888384414106</c:v>
                  </c:pt>
                  <c:pt idx="2">
                    <c:v>0.0759951507517611</c:v>
                  </c:pt>
                  <c:pt idx="3">
                    <c:v>0.0394551832623464</c:v>
                  </c:pt>
                  <c:pt idx="4">
                    <c:v>0.0734949964298034</c:v>
                  </c:pt>
                  <c:pt idx="5">
                    <c:v>0.0426781995548663</c:v>
                  </c:pt>
                  <c:pt idx="6">
                    <c:v>0.0724874902815153</c:v>
                  </c:pt>
                  <c:pt idx="7">
                    <c:v>0.0308229216353637</c:v>
                  </c:pt>
                  <c:pt idx="8">
                    <c:v>0.0850896698880536</c:v>
                  </c:pt>
                </c:numCache>
              </c:numRef>
            </c:plus>
            <c:minus>
              <c:numRef>
                <c:f>('AreaX_Average, AAV only'!$B$45,'AreaX_Average, AAV only'!$D$45:$K$45)</c:f>
                <c:numCache>
                  <c:formatCode>General</c:formatCode>
                  <c:ptCount val="9"/>
                  <c:pt idx="0">
                    <c:v>0.058021196097363</c:v>
                  </c:pt>
                  <c:pt idx="1">
                    <c:v>0.0168888384414106</c:v>
                  </c:pt>
                  <c:pt idx="2">
                    <c:v>0.0759951507517611</c:v>
                  </c:pt>
                  <c:pt idx="3">
                    <c:v>0.0394551832623464</c:v>
                  </c:pt>
                  <c:pt idx="4">
                    <c:v>0.0734949964298034</c:v>
                  </c:pt>
                  <c:pt idx="5">
                    <c:v>0.0426781995548663</c:v>
                  </c:pt>
                  <c:pt idx="6">
                    <c:v>0.0724874902815153</c:v>
                  </c:pt>
                  <c:pt idx="7">
                    <c:v>0.0308229216353637</c:v>
                  </c:pt>
                  <c:pt idx="8">
                    <c:v>0.085089669888053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('AreaX_Average, AAV only'!$B$43,'AreaX_Average, AAV only'!$D$43:$K$43)</c:f>
              <c:numCache>
                <c:formatCode>General</c:formatCode>
                <c:ptCount val="9"/>
                <c:pt idx="0">
                  <c:v>-0.0170628778612287</c:v>
                </c:pt>
                <c:pt idx="1">
                  <c:v>-0.0632657362098841</c:v>
                </c:pt>
                <c:pt idx="2">
                  <c:v>-0.0345211729195666</c:v>
                </c:pt>
                <c:pt idx="3">
                  <c:v>-0.0121095313035329</c:v>
                </c:pt>
                <c:pt idx="4">
                  <c:v>-0.0318096166196559</c:v>
                </c:pt>
                <c:pt idx="5">
                  <c:v>-0.0116113454023706</c:v>
                </c:pt>
                <c:pt idx="6">
                  <c:v>-0.0324208100149676</c:v>
                </c:pt>
                <c:pt idx="7">
                  <c:v>-0.0203497386950718</c:v>
                </c:pt>
                <c:pt idx="8">
                  <c:v>-0.007727350435506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1F4-4DB8-BEC6-1628FE9089C9}"/>
            </c:ext>
          </c:extLst>
        </c:ser>
        <c:ser>
          <c:idx val="3"/>
          <c:order val="4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(fadfad!$B$91,fadfad!$D$91:$K$91)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1F4-4DB8-BEC6-1628FE9089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2343080"/>
        <c:axId val="-2002448552"/>
      </c:barChart>
      <c:catAx>
        <c:axId val="-207234308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solidFill>
            <a:schemeClr val="tx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02448552"/>
        <c:crosses val="autoZero"/>
        <c:auto val="1"/>
        <c:lblAlgn val="ctr"/>
        <c:lblOffset val="100"/>
        <c:noMultiLvlLbl val="0"/>
      </c:catAx>
      <c:valAx>
        <c:axId val="-2002448552"/>
        <c:scaling>
          <c:orientation val="minMax"/>
          <c:max val="0.24"/>
          <c:min val="-0.2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72343080"/>
        <c:crosses val="autoZero"/>
        <c:crossBetween val="between"/>
        <c:majorUnit val="0.1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9965346784229"/>
          <c:y val="0.0521339928520752"/>
          <c:w val="0.630173327991184"/>
          <c:h val="0.922108887053816"/>
        </c:manualLayout>
      </c:layout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Z$50</c:f>
                <c:numCache>
                  <c:formatCode>General</c:formatCode>
                  <c:ptCount val="1"/>
                  <c:pt idx="0">
                    <c:v>0.00122143444927622</c:v>
                  </c:pt>
                </c:numCache>
              </c:numRef>
            </c:plus>
            <c:minus>
              <c:numRef>
                <c:f>'AreaX_Average, HSV only'!$AA$50</c:f>
                <c:numCache>
                  <c:formatCode>General</c:formatCode>
                  <c:ptCount val="1"/>
                  <c:pt idx="0">
                    <c:v>0.00282799767125198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HSV only'!$Z$48</c:f>
              <c:numCache>
                <c:formatCode>General</c:formatCode>
                <c:ptCount val="1"/>
                <c:pt idx="0">
                  <c:v>-0.003496370154074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8DB-4D2D-B98F-F5A0188BD339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bg1">
                <a:lumMod val="50000"/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Z$55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plus>
            <c:minus>
              <c:numRef>
                <c:f>'AreaX_Average, HSV only'!$Z$55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AreaX_Average, HSV only'!$Z$53</c:f>
              <c:numCache>
                <c:formatCode>General</c:formatCode>
                <c:ptCount val="1"/>
                <c:pt idx="0">
                  <c:v>0.0001128853422126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8DB-4D2D-B98F-F5A0188BD339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HSV only'!$Z$45</c:f>
                <c:numCache>
                  <c:formatCode>General</c:formatCode>
                  <c:ptCount val="1"/>
                  <c:pt idx="0">
                    <c:v>0.00171794659144359</c:v>
                  </c:pt>
                </c:numCache>
              </c:numRef>
            </c:plus>
            <c:minus>
              <c:numRef>
                <c:f>'AreaX_Average, HSV only'!$Z$45</c:f>
                <c:numCache>
                  <c:formatCode>General</c:formatCode>
                  <c:ptCount val="1"/>
                  <c:pt idx="0">
                    <c:v>0.00171794659144359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HSV only'!$Z$43</c:f>
              <c:numCache>
                <c:formatCode>General</c:formatCode>
                <c:ptCount val="1"/>
                <c:pt idx="0">
                  <c:v>0.006714043325879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8DB-4D2D-B98F-F5A0188BD339}"/>
            </c:ext>
          </c:extLst>
        </c:ser>
        <c:ser>
          <c:idx val="3"/>
          <c:order val="3"/>
          <c:tx>
            <c:strRef>
              <c:f>fadfad!$AB$91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fadfad!$AB$91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8DB-4D2D-B98F-F5A0188BD3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72379352"/>
        <c:axId val="1876097384"/>
      </c:barChart>
      <c:catAx>
        <c:axId val="-2072379352"/>
        <c:scaling>
          <c:orientation val="minMax"/>
        </c:scaling>
        <c:delete val="0"/>
        <c:axPos val="t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6097384"/>
        <c:crosses val="autoZero"/>
        <c:auto val="1"/>
        <c:lblAlgn val="ctr"/>
        <c:lblOffset val="100"/>
        <c:noMultiLvlLbl val="0"/>
      </c:catAx>
      <c:valAx>
        <c:axId val="1876097384"/>
        <c:scaling>
          <c:orientation val="maxMin"/>
          <c:max val="0.01"/>
          <c:min val="-0.0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72379352"/>
        <c:crosses val="autoZero"/>
        <c:crossBetween val="between"/>
        <c:majorUnit val="0.00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9965346784229"/>
          <c:y val="0.0521339928520752"/>
          <c:w val="0.630173327991184"/>
          <c:h val="0.922108887053816"/>
        </c:manualLayout>
      </c:layout>
      <c:barChart>
        <c:barDir val="col"/>
        <c:grouping val="clustered"/>
        <c:varyColors val="0"/>
        <c:ser>
          <c:idx val="0"/>
          <c:order val="0"/>
          <c:tx>
            <c:v>Dreadds4'</c:v>
          </c:tx>
          <c:spPr>
            <a:solidFill>
              <a:srgbClr val="00B0F0">
                <a:alpha val="10000"/>
              </a:srgbClr>
            </a:solidFill>
            <a:ln w="1270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Z$50</c:f>
                <c:numCache>
                  <c:formatCode>General</c:formatCode>
                  <c:ptCount val="1"/>
                  <c:pt idx="0">
                    <c:v>0.00545893041582662</c:v>
                  </c:pt>
                </c:numCache>
              </c:numRef>
            </c:plus>
            <c:minus>
              <c:numRef>
                <c:f>'AreaX_Average, AAV only'!$AA$50</c:f>
                <c:numCache>
                  <c:formatCode>General</c:formatCode>
                  <c:ptCount val="1"/>
                  <c:pt idx="0">
                    <c:v>0.00519302209997026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0070C0"/>
                </a:solidFill>
                <a:round/>
              </a:ln>
              <a:effectLst/>
            </c:spPr>
          </c:errBars>
          <c:val>
            <c:numRef>
              <c:f>'AreaX_Average, AAV only'!$Z$48</c:f>
              <c:numCache>
                <c:formatCode>General</c:formatCode>
                <c:ptCount val="1"/>
                <c:pt idx="0">
                  <c:v>-0.007566074375939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8DB-4D2D-B98F-F5A0188BD339}"/>
            </c:ext>
          </c:extLst>
        </c:ser>
        <c:ser>
          <c:idx val="2"/>
          <c:order val="1"/>
          <c:tx>
            <c:v>mCherry</c:v>
          </c:tx>
          <c:spPr>
            <a:solidFill>
              <a:schemeClr val="bg1">
                <a:lumMod val="50000"/>
                <a:alpha val="3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Z$55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plus>
            <c:minus>
              <c:numRef>
                <c:f>'AreaX_Average, AAV only'!$Z$55</c:f>
                <c:numCache>
                  <c:formatCode>General</c:formatCode>
                  <c:ptCount val="1"/>
                  <c:pt idx="0">
                    <c:v>0.0011204973249797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AreaX_Average, AAV only'!$Z$53</c:f>
              <c:numCache>
                <c:formatCode>General</c:formatCode>
                <c:ptCount val="1"/>
                <c:pt idx="0">
                  <c:v>0.0001128853422126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8DB-4D2D-B98F-F5A0188BD339}"/>
            </c:ext>
          </c:extLst>
        </c:ser>
        <c:ser>
          <c:idx val="1"/>
          <c:order val="2"/>
          <c:tx>
            <c:v>Dreadds3</c:v>
          </c:tx>
          <c:spPr>
            <a:solidFill>
              <a:srgbClr val="FF0000">
                <a:alpha val="10000"/>
              </a:srgbClr>
            </a:solidFill>
            <a:ln w="1270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'AreaX_Average, AAV only'!$Z$45</c:f>
                <c:numCache>
                  <c:formatCode>General</c:formatCode>
                  <c:ptCount val="1"/>
                  <c:pt idx="0">
                    <c:v>0.00347696721088754</c:v>
                  </c:pt>
                </c:numCache>
              </c:numRef>
            </c:plus>
            <c:minus>
              <c:numRef>
                <c:f>'AreaX_Average, AAV only'!$Z$45</c:f>
                <c:numCache>
                  <c:formatCode>General</c:formatCode>
                  <c:ptCount val="1"/>
                  <c:pt idx="0">
                    <c:v>0.00347696721088754</c:v>
                  </c:pt>
                </c:numCache>
              </c:numRef>
            </c:minus>
            <c:spPr>
              <a:noFill/>
              <a:ln w="12700" cap="flat" cmpd="sng" algn="ctr">
                <a:solidFill>
                  <a:srgbClr val="FF0000"/>
                </a:solidFill>
                <a:round/>
              </a:ln>
              <a:effectLst/>
            </c:spPr>
          </c:errBars>
          <c:val>
            <c:numRef>
              <c:f>'AreaX_Average, AAV only'!$Z$43</c:f>
              <c:numCache>
                <c:formatCode>General</c:formatCode>
                <c:ptCount val="1"/>
                <c:pt idx="0">
                  <c:v>0.0038560194267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8DB-4D2D-B98F-F5A0188BD339}"/>
            </c:ext>
          </c:extLst>
        </c:ser>
        <c:ser>
          <c:idx val="3"/>
          <c:order val="3"/>
          <c:tx>
            <c:strRef>
              <c:f>fadfad!$AB$91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fadfad!$AB$91</c:f>
              <c:numCache>
                <c:formatCode>General</c:formatCode>
                <c:ptCount val="1"/>
                <c:pt idx="0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8DB-4D2D-B98F-F5A0188BD3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10901416"/>
        <c:axId val="-2092127064"/>
      </c:barChart>
      <c:catAx>
        <c:axId val="1810901416"/>
        <c:scaling>
          <c:orientation val="minMax"/>
        </c:scaling>
        <c:delete val="0"/>
        <c:axPos val="t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092127064"/>
        <c:crosses val="autoZero"/>
        <c:auto val="1"/>
        <c:lblAlgn val="ctr"/>
        <c:lblOffset val="100"/>
        <c:noMultiLvlLbl val="0"/>
      </c:catAx>
      <c:valAx>
        <c:axId val="-2092127064"/>
        <c:scaling>
          <c:orientation val="maxMin"/>
          <c:max val="0.016"/>
          <c:min val="-0.01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0901416"/>
        <c:crosses val="autoZero"/>
        <c:crossBetween val="between"/>
        <c:majorUnit val="0.008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336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198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41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326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58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3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73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39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005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433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34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B4A73-A334-4919-8CF7-7DD6E172AE85}" type="datetimeFigureOut">
              <a:rPr lang="en-US" smtClean="0"/>
              <a:t>11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F1043-D4A0-4013-908F-C360E1C71A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88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2925" y="-2484648"/>
            <a:ext cx="10515600" cy="1325563"/>
          </a:xfrm>
        </p:spPr>
        <p:txBody>
          <a:bodyPr>
            <a:normAutofit/>
          </a:bodyPr>
          <a:lstStyle/>
          <a:p>
            <a:r>
              <a:rPr lang="en-US" sz="2000" dirty="0" smtClean="0"/>
              <a:t>Area X – separated by virus; Rendition-to-rendition variability</a:t>
            </a:r>
            <a:endParaRPr lang="en-US" sz="2000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2509336"/>
              </p:ext>
            </p:extLst>
          </p:nvPr>
        </p:nvGraphicFramePr>
        <p:xfrm>
          <a:off x="435613" y="1021588"/>
          <a:ext cx="73152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5107063"/>
              </p:ext>
            </p:extLst>
          </p:nvPr>
        </p:nvGraphicFramePr>
        <p:xfrm>
          <a:off x="438150" y="4229099"/>
          <a:ext cx="73152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6359152"/>
              </p:ext>
            </p:extLst>
          </p:nvPr>
        </p:nvGraphicFramePr>
        <p:xfrm>
          <a:off x="8937295" y="964438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0995612"/>
              </p:ext>
            </p:extLst>
          </p:nvPr>
        </p:nvGraphicFramePr>
        <p:xfrm>
          <a:off x="8937295" y="4229099"/>
          <a:ext cx="16459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266700" y="662287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smtClean="0"/>
              <a:t>HSV only </a:t>
            </a:r>
            <a:endParaRPr lang="en-US" b="1" u="sng" dirty="0"/>
          </a:p>
        </p:txBody>
      </p:sp>
      <p:sp>
        <p:nvSpPr>
          <p:cNvPr id="9" name="TextBox 8"/>
          <p:cNvSpPr txBox="1"/>
          <p:nvPr/>
        </p:nvSpPr>
        <p:spPr>
          <a:xfrm>
            <a:off x="933450" y="934024"/>
            <a:ext cx="7037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plitude    Duration           FF               Pitch             FM              AM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           Entropy    Goodness     Mean Freq</a:t>
            </a:r>
            <a:r>
              <a:rPr lang="en-US" sz="1200" dirty="0"/>
              <a:t>.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33450" y="4040832"/>
            <a:ext cx="70376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plitude    Duration           FF               Pitch             FM              AM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           Entropy    Goodness     Mean Freq</a:t>
            </a:r>
            <a:r>
              <a:rPr lang="en-US" sz="1200" dirty="0"/>
              <a:t>.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-1004894" y="200650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-1004895" y="5259821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7442083" y="1946179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7442083" y="5259820"/>
            <a:ext cx="27149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odulation Index (CNO-Sal)/(</a:t>
            </a:r>
            <a:r>
              <a:rPr lang="en-US" sz="1200" dirty="0" err="1" smtClean="0"/>
              <a:t>CNO+Sal</a:t>
            </a:r>
            <a:r>
              <a:rPr lang="en-US" sz="1200" dirty="0"/>
              <a:t>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14093" y="3647032"/>
            <a:ext cx="11068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err="1" smtClean="0"/>
              <a:t>CaMKII</a:t>
            </a:r>
            <a:r>
              <a:rPr lang="en-US" b="1" u="sng" dirty="0" smtClean="0"/>
              <a:t> AAV only </a:t>
            </a:r>
            <a:endParaRPr lang="en-US" b="1" u="sng" dirty="0"/>
          </a:p>
        </p:txBody>
      </p:sp>
      <p:sp>
        <p:nvSpPr>
          <p:cNvPr id="22" name="TextBox 21"/>
          <p:cNvSpPr txBox="1"/>
          <p:nvPr/>
        </p:nvSpPr>
        <p:spPr>
          <a:xfrm>
            <a:off x="86826" y="143089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440480" y="143089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-53216" y="3609762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357588" y="3609762"/>
            <a:ext cx="208597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814895" y="831433"/>
            <a:ext cx="21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dentity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9734532" y="4040831"/>
            <a:ext cx="211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dentity</a:t>
            </a:r>
          </a:p>
        </p:txBody>
      </p:sp>
    </p:spTree>
    <p:extLst>
      <p:ext uri="{BB962C8B-B14F-4D97-AF65-F5344CB8AC3E}">
        <p14:creationId xmlns:p14="http://schemas.microsoft.com/office/powerpoint/2010/main" val="8541157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94</TotalTime>
  <Words>98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rea X – separated by virus; Rendition-to-rendition variability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hite Lab</dc:creator>
  <cp:lastModifiedBy>Jon Heston</cp:lastModifiedBy>
  <cp:revision>65</cp:revision>
  <dcterms:created xsi:type="dcterms:W3CDTF">2016-02-17T18:00:22Z</dcterms:created>
  <dcterms:modified xsi:type="dcterms:W3CDTF">2016-11-30T07:09:58Z</dcterms:modified>
</cp:coreProperties>
</file>